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8" name="图片 7" descr="Figure 5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6690" y="269875"/>
            <a:ext cx="5818505" cy="651637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86690" y="209550"/>
            <a:ext cx="104775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Figure 5a</a:t>
            </a:r>
            <a:endParaRPr lang="en-US" altLang="zh-CN" b="1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20435" y="209550"/>
            <a:ext cx="10572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Figure 5d</a:t>
            </a:r>
            <a:endParaRPr lang="en-US" altLang="zh-CN" b="1">
              <a:solidFill>
                <a:srgbClr val="FF0000"/>
              </a:solidFill>
            </a:endParaRPr>
          </a:p>
        </p:txBody>
      </p:sp>
      <p:pic>
        <p:nvPicPr>
          <p:cNvPr id="11" name="图片 10" descr="Figure 5d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77710" y="70485"/>
            <a:ext cx="4404360" cy="646176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ure 5e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502920" y="0"/>
            <a:ext cx="5273040" cy="6858000"/>
          </a:xfrm>
          <a:prstGeom prst="rect">
            <a:avLst/>
          </a:prstGeom>
        </p:spPr>
      </p:pic>
      <p:pic>
        <p:nvPicPr>
          <p:cNvPr id="7" name="图片 6" descr="Figure 5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7775" y="52070"/>
            <a:ext cx="5987415" cy="680593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0" y="0"/>
            <a:ext cx="104965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Figure 5e</a:t>
            </a:r>
            <a:endParaRPr lang="en-US" altLang="zh-CN" b="1">
              <a:solidFill>
                <a:srgbClr val="FF0000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6102350" y="0"/>
            <a:ext cx="100711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Figure 5f</a:t>
            </a:r>
            <a:endParaRPr lang="en-US" altLang="zh-CN" b="1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Figure 5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292100"/>
            <a:ext cx="6621780" cy="62738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0" y="0"/>
            <a:ext cx="105727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Figure 5h</a:t>
            </a:r>
            <a:endParaRPr lang="en-US" altLang="zh-CN" b="1">
              <a:solidFill>
                <a:srgbClr val="FF0000"/>
              </a:solidFill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6161405" y="117475"/>
            <a:ext cx="6391910" cy="6447790"/>
            <a:chOff x="9703" y="185"/>
            <a:chExt cx="10066" cy="10154"/>
          </a:xfrm>
        </p:grpSpPr>
        <p:pic>
          <p:nvPicPr>
            <p:cNvPr id="5" name="图片 4" descr="figure 5i-new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703" y="185"/>
              <a:ext cx="10066" cy="10155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9758" y="187"/>
              <a:ext cx="1755" cy="7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8" name="文本框 7"/>
          <p:cNvSpPr txBox="1"/>
          <p:nvPr/>
        </p:nvSpPr>
        <p:spPr>
          <a:xfrm>
            <a:off x="6196330" y="117475"/>
            <a:ext cx="99060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Figure 5i</a:t>
            </a:r>
            <a:endParaRPr lang="en-US" altLang="zh-CN" b="1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Figure S4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6355" y="0"/>
            <a:ext cx="3231515" cy="6858000"/>
          </a:xfrm>
          <a:prstGeom prst="rect">
            <a:avLst/>
          </a:prstGeom>
        </p:spPr>
      </p:pic>
      <p:pic>
        <p:nvPicPr>
          <p:cNvPr id="4" name="图片 3" descr="Figure S4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3960" y="1527810"/>
            <a:ext cx="7178040" cy="1813560"/>
          </a:xfrm>
          <a:prstGeom prst="rect">
            <a:avLst/>
          </a:prstGeom>
        </p:spPr>
      </p:pic>
      <p:pic>
        <p:nvPicPr>
          <p:cNvPr id="3" name="图片 2" descr="Figure S4b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0110" y="0"/>
            <a:ext cx="4217035" cy="68580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0" y="0"/>
            <a:ext cx="143573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sup Figure 4a</a:t>
            </a:r>
            <a:endParaRPr lang="en-US" altLang="zh-CN" b="1">
              <a:solidFill>
                <a:srgbClr val="FF0000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277870" y="76835"/>
            <a:ext cx="144526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sup Figure 4b</a:t>
            </a:r>
            <a:endParaRPr lang="en-US" altLang="zh-CN" b="1">
              <a:solidFill>
                <a:srgbClr val="FF0000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402830" y="1097915"/>
            <a:ext cx="14185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rgbClr val="FF0000"/>
                </a:solidFill>
              </a:rPr>
              <a:t>sup Figure 4c</a:t>
            </a:r>
            <a:endParaRPr lang="en-US" altLang="zh-CN" b="1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10800,&quot;width&quot;:8304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WPS 演示</Application>
  <PresentationFormat>宽屏</PresentationFormat>
  <Paragraphs>1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1" baseType="lpstr">
      <vt:lpstr>Arial</vt:lpstr>
      <vt:lpstr>宋体</vt:lpstr>
      <vt:lpstr>Wingdings</vt:lpstr>
      <vt:lpstr>Arial Unicode MS</vt:lpstr>
      <vt:lpstr>Calibri</vt:lpstr>
      <vt:lpstr>微软雅黑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Administrator</cp:lastModifiedBy>
  <cp:revision>7</cp:revision>
  <dcterms:created xsi:type="dcterms:W3CDTF">2021-05-07T12:11:00Z</dcterms:created>
  <dcterms:modified xsi:type="dcterms:W3CDTF">2021-05-07T13:00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733B5A42D6044BC92044D79F64F4B38</vt:lpwstr>
  </property>
  <property fmtid="{D5CDD505-2E9C-101B-9397-08002B2CF9AE}" pid="3" name="KSOProductBuildVer">
    <vt:lpwstr>2052-11.1.0.10463</vt:lpwstr>
  </property>
</Properties>
</file>